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9" r:id="rId2"/>
    <p:sldId id="270" r:id="rId3"/>
    <p:sldId id="271" r:id="rId4"/>
  </p:sldIdLst>
  <p:sldSz cx="12192000" cy="6858000"/>
  <p:notesSz cx="6858000" cy="9144000"/>
  <p:defaultTextStyle>
    <a:defPPr>
      <a:defRPr lang="en-JP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74"/>
  </p:normalViewPr>
  <p:slideViewPr>
    <p:cSldViewPr snapToGrid="0">
      <p:cViewPr>
        <p:scale>
          <a:sx n="75" d="100"/>
          <a:sy n="75" d="100"/>
        </p:scale>
        <p:origin x="525" y="3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974510-CDC5-739D-73A1-2E988D04E68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B29F878-58BF-FCA4-37CA-0AC581F29AC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46A243-E47B-EEDA-0CA2-CD74572219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350FA-4814-D34B-96A5-C8D129D4C723}" type="datetimeFigureOut">
              <a:rPr lang="en-JP" smtClean="0"/>
              <a:t>11/20/2025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42FF14-D0E4-4BCD-F73D-37F0F43700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0AC654-D3C3-B970-8A78-E836B64E11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4DEAC-38A7-FB46-839B-C6B809AD930A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2539270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6D0CAF-44D8-1188-FD0B-27A2F01D25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89A30C8-6B84-D181-147A-2B1CC666AC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CDA039-C6D0-B6E8-936D-20D7DF4651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350FA-4814-D34B-96A5-C8D129D4C723}" type="datetimeFigureOut">
              <a:rPr lang="en-JP" smtClean="0"/>
              <a:t>11/20/2025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9C077B-3F5D-63C3-70E1-259205B796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C6AC64-1C0C-F779-5552-271D412D6A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4DEAC-38A7-FB46-839B-C6B809AD930A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8781457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C670562-1703-A8B5-1AB8-E1DF2CF2869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50861B5-71D9-C17D-DFDF-013D191718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E4BC17-C7E4-8150-A9D2-D6917F9797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350FA-4814-D34B-96A5-C8D129D4C723}" type="datetimeFigureOut">
              <a:rPr lang="en-JP" smtClean="0"/>
              <a:t>11/20/2025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9F69DF-96EB-18D9-28D1-B1141EB8C7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B9559F-7CF6-0465-F4F9-72841CFD6E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4DEAC-38A7-FB46-839B-C6B809AD930A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175258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21255A-10E4-63F1-C6BF-48AB80F0D9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062902F-D1FD-9CD9-2E84-6888F74AAE4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169E60-24FA-541F-3532-16D03185FD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350FA-4814-D34B-96A5-C8D129D4C723}" type="datetimeFigureOut">
              <a:rPr lang="en-JP" smtClean="0"/>
              <a:t>11/20/2025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323E5D-F0D0-B07E-71C5-5000EC3DB5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ABAFBC-E41E-52D6-A940-C27A30411E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4DEAC-38A7-FB46-839B-C6B809AD930A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5143317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12BD61-5C9A-C065-0A52-00795417F2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E61DD9D-B592-5CB9-1959-3148327F6E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6426B2-9B75-DAF4-1571-02C99431AC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350FA-4814-D34B-96A5-C8D129D4C723}" type="datetimeFigureOut">
              <a:rPr lang="en-JP" smtClean="0"/>
              <a:t>11/20/2025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E1855F-1C45-D797-415D-FB62D3B71D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AFF975-C899-179B-C94F-8582502B20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4DEAC-38A7-FB46-839B-C6B809AD930A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5470087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652081-B3F5-883F-C2D5-86804BBC38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9FCCE7C-AF0C-8355-4E5F-3D9612C2B44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5197909-CF8D-A70A-AB87-ED5B7C5C338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9629B6C-228D-DDC3-CB5D-6642C1927D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350FA-4814-D34B-96A5-C8D129D4C723}" type="datetimeFigureOut">
              <a:rPr lang="en-JP" smtClean="0"/>
              <a:t>11/20/2025</a:t>
            </a:fld>
            <a:endParaRPr lang="en-JP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F83246E-355F-98D8-34E4-F17B098AC1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4AFEF68-FE25-F9FF-5437-CF2F479E1C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4DEAC-38A7-FB46-839B-C6B809AD930A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3414102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111E59-0D4B-667B-1D0E-BE0694F8B1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08D87DE-3992-214C-C3C9-694B86CE64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16ACC30-2515-4669-F265-D602BB272E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0F515AA-7DBD-FE0E-0631-EA2DCED1A40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0990F10-D10B-8D8D-2181-174C8C05898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5656444-2708-FC1B-9F63-5B8CAAB538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350FA-4814-D34B-96A5-C8D129D4C723}" type="datetimeFigureOut">
              <a:rPr lang="en-JP" smtClean="0"/>
              <a:t>11/20/2025</a:t>
            </a:fld>
            <a:endParaRPr lang="en-JP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DC4E464-9A0E-FFB9-5986-BD05CA5675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DC19DF0-F785-0A42-6AF9-BC11CFCBD1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4DEAC-38A7-FB46-839B-C6B809AD930A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3040817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918021-71D6-7F49-87AB-06E3164F48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057CCE0-677F-9D3A-2179-9107E25B18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350FA-4814-D34B-96A5-C8D129D4C723}" type="datetimeFigureOut">
              <a:rPr lang="en-JP" smtClean="0"/>
              <a:t>11/20/2025</a:t>
            </a:fld>
            <a:endParaRPr lang="en-JP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E78ABED-98DF-188D-AA7D-F6563932A9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DEE820B-6AC4-06A1-769C-2B0DB065DB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4DEAC-38A7-FB46-839B-C6B809AD930A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7545836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96541D1-F08F-CE83-2D83-0E64805B99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350FA-4814-D34B-96A5-C8D129D4C723}" type="datetimeFigureOut">
              <a:rPr lang="en-JP" smtClean="0"/>
              <a:t>11/20/2025</a:t>
            </a:fld>
            <a:endParaRPr lang="en-JP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983A2BE-19AB-BB6A-83F7-A1840B5F5C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0E2FA65-FB10-5404-E246-97A7A5EC47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4DEAC-38A7-FB46-839B-C6B809AD930A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4125236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7230E0-545E-601A-50C6-C775D8658D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7407CE9-7431-D4B7-66EC-42C20DCF829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1FA78EE-7B13-3590-6BC7-9D185B744DD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17A8247-6D79-AA21-FAD1-B05C7A4B5B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350FA-4814-D34B-96A5-C8D129D4C723}" type="datetimeFigureOut">
              <a:rPr lang="en-JP" smtClean="0"/>
              <a:t>11/20/2025</a:t>
            </a:fld>
            <a:endParaRPr lang="en-JP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05EA4B7-7191-1270-38AE-342F54DFEF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5059B1F-3803-870D-374A-518EFE9F74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4DEAC-38A7-FB46-839B-C6B809AD930A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1019086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93768B-E6E6-025F-37C5-5D24C94216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537840E-439C-03D0-888B-B4B01309DC3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JP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B2B94DC-133A-8C77-4882-6D6471F3C64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0AE8E21-18A0-5916-0B67-4C8EF13FD5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350FA-4814-D34B-96A5-C8D129D4C723}" type="datetimeFigureOut">
              <a:rPr lang="en-JP" smtClean="0"/>
              <a:t>11/20/2025</a:t>
            </a:fld>
            <a:endParaRPr lang="en-JP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80A63B1-29B5-3B97-71CF-CA40101975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C9129D3-5DB3-2C68-A77A-AADD7A1040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4DEAC-38A7-FB46-839B-C6B809AD930A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5058054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6A28EA8-47FE-48E5-32F6-3EAD783691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88F1BC1-8ED3-2BD4-4C03-8E22C7D9EB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5CE544-8442-9166-CD2B-CCC7BDB0AE5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C350FA-4814-D34B-96A5-C8D129D4C723}" type="datetimeFigureOut">
              <a:rPr lang="en-JP" smtClean="0"/>
              <a:t>11/20/2025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D49729-C1F9-1520-D1C3-F57F10DE71F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77CF5C-C42A-682E-3A53-A4EDFF5E1F1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04DEAC-38A7-FB46-839B-C6B809AD930A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41953748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JP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Arrow: Right 7">
            <a:extLst>
              <a:ext uri="{FF2B5EF4-FFF2-40B4-BE49-F238E27FC236}">
                <a16:creationId xmlns:a16="http://schemas.microsoft.com/office/drawing/2014/main" id="{540E1945-128B-4809-8D76-9D129351D046}"/>
              </a:ext>
            </a:extLst>
          </p:cNvPr>
          <p:cNvSpPr/>
          <p:nvPr/>
        </p:nvSpPr>
        <p:spPr>
          <a:xfrm rot="16200000">
            <a:off x="2884110" y="2014426"/>
            <a:ext cx="722812" cy="209006"/>
          </a:xfrm>
          <a:prstGeom prst="rightArrow">
            <a:avLst/>
          </a:prstGeom>
          <a:solidFill>
            <a:schemeClr val="bg1">
              <a:lumMod val="75000"/>
            </a:schemeClr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F725CD9C-ED8E-4D0F-903A-96BDBB6A67CF}"/>
              </a:ext>
            </a:extLst>
          </p:cNvPr>
          <p:cNvSpPr/>
          <p:nvPr/>
        </p:nvSpPr>
        <p:spPr>
          <a:xfrm>
            <a:off x="2437076" y="716987"/>
            <a:ext cx="1639933" cy="996779"/>
          </a:xfrm>
          <a:prstGeom prst="rect">
            <a:avLst/>
          </a:prstGeom>
          <a:solidFill>
            <a:schemeClr val="bg1">
              <a:lumMod val="75000"/>
            </a:schemeClr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Washing &amp; Air-Drying (25°C, 15 days)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226A54D6-A2E5-433D-BD03-5B2464DD8FB1}"/>
              </a:ext>
            </a:extLst>
          </p:cNvPr>
          <p:cNvSpPr/>
          <p:nvPr/>
        </p:nvSpPr>
        <p:spPr>
          <a:xfrm>
            <a:off x="4930060" y="725468"/>
            <a:ext cx="1639933" cy="996779"/>
          </a:xfrm>
          <a:prstGeom prst="rect">
            <a:avLst/>
          </a:prstGeom>
          <a:solidFill>
            <a:schemeClr val="bg1">
              <a:lumMod val="75000"/>
            </a:schemeClr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rinding to Fine Powder &amp; Storage </a:t>
            </a:r>
          </a:p>
        </p:txBody>
      </p:sp>
      <p:sp>
        <p:nvSpPr>
          <p:cNvPr id="21" name="Arrow: Right 20">
            <a:extLst>
              <a:ext uri="{FF2B5EF4-FFF2-40B4-BE49-F238E27FC236}">
                <a16:creationId xmlns:a16="http://schemas.microsoft.com/office/drawing/2014/main" id="{C8699890-72CA-403E-93B9-E39D4A12C083}"/>
              </a:ext>
            </a:extLst>
          </p:cNvPr>
          <p:cNvSpPr/>
          <p:nvPr/>
        </p:nvSpPr>
        <p:spPr>
          <a:xfrm>
            <a:off x="4149750" y="1110874"/>
            <a:ext cx="722812" cy="209006"/>
          </a:xfrm>
          <a:prstGeom prst="rightArrow">
            <a:avLst/>
          </a:prstGeom>
          <a:solidFill>
            <a:schemeClr val="bg1">
              <a:lumMod val="75000"/>
            </a:schemeClr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E9C01C8C-4903-446D-BBDE-A939B94BBB34}"/>
              </a:ext>
            </a:extLst>
          </p:cNvPr>
          <p:cNvSpPr/>
          <p:nvPr/>
        </p:nvSpPr>
        <p:spPr>
          <a:xfrm>
            <a:off x="7445094" y="725227"/>
            <a:ext cx="2190740" cy="996779"/>
          </a:xfrm>
          <a:prstGeom prst="rect">
            <a:avLst/>
          </a:prstGeom>
          <a:solidFill>
            <a:schemeClr val="bg1">
              <a:lumMod val="75000"/>
            </a:schemeClr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traction (powder + solvent) </a:t>
            </a:r>
          </a:p>
          <a:p>
            <a:pPr algn="ctr"/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olvents: Methanol, n-Butanol, n-Hexane, Chloroform </a:t>
            </a:r>
          </a:p>
          <a:p>
            <a:pPr algn="ctr"/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7 days, intermittent shaking) </a:t>
            </a:r>
          </a:p>
        </p:txBody>
      </p:sp>
      <p:sp>
        <p:nvSpPr>
          <p:cNvPr id="24" name="Arrow: Right 23">
            <a:extLst>
              <a:ext uri="{FF2B5EF4-FFF2-40B4-BE49-F238E27FC236}">
                <a16:creationId xmlns:a16="http://schemas.microsoft.com/office/drawing/2014/main" id="{CF05C14D-1D88-48FE-9B38-8A2A55C0DA65}"/>
              </a:ext>
            </a:extLst>
          </p:cNvPr>
          <p:cNvSpPr/>
          <p:nvPr/>
        </p:nvSpPr>
        <p:spPr>
          <a:xfrm>
            <a:off x="6643376" y="1055766"/>
            <a:ext cx="722812" cy="209006"/>
          </a:xfrm>
          <a:prstGeom prst="rightArrow">
            <a:avLst/>
          </a:prstGeom>
          <a:solidFill>
            <a:schemeClr val="bg1">
              <a:lumMod val="75000"/>
            </a:schemeClr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3AE3E3D8-1542-4456-A8DC-723E8E844B76}"/>
              </a:ext>
            </a:extLst>
          </p:cNvPr>
          <p:cNvSpPr/>
          <p:nvPr/>
        </p:nvSpPr>
        <p:spPr>
          <a:xfrm>
            <a:off x="7445094" y="2587249"/>
            <a:ext cx="2190740" cy="996779"/>
          </a:xfrm>
          <a:prstGeom prst="rect">
            <a:avLst/>
          </a:prstGeom>
          <a:solidFill>
            <a:schemeClr val="bg1">
              <a:lumMod val="75000"/>
            </a:schemeClr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ltration &amp; Rotary Evaporation (40°C) Concentrated, Thick Extracts (vacuum dried)</a:t>
            </a:r>
          </a:p>
        </p:txBody>
      </p:sp>
      <p:sp>
        <p:nvSpPr>
          <p:cNvPr id="26" name="Arrow: Right 25">
            <a:extLst>
              <a:ext uri="{FF2B5EF4-FFF2-40B4-BE49-F238E27FC236}">
                <a16:creationId xmlns:a16="http://schemas.microsoft.com/office/drawing/2014/main" id="{0CB57212-96C1-48A3-988B-D775E57F5706}"/>
              </a:ext>
            </a:extLst>
          </p:cNvPr>
          <p:cNvSpPr/>
          <p:nvPr/>
        </p:nvSpPr>
        <p:spPr>
          <a:xfrm rot="5400000">
            <a:off x="8179058" y="2054223"/>
            <a:ext cx="722812" cy="209006"/>
          </a:xfrm>
          <a:prstGeom prst="rightArrow">
            <a:avLst/>
          </a:prstGeom>
          <a:solidFill>
            <a:schemeClr val="bg1">
              <a:lumMod val="75000"/>
            </a:schemeClr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1C2C9B87-061B-41C3-A795-C6917E5246EF}"/>
              </a:ext>
            </a:extLst>
          </p:cNvPr>
          <p:cNvSpPr/>
          <p:nvPr/>
        </p:nvSpPr>
        <p:spPr>
          <a:xfrm>
            <a:off x="4986555" y="2587248"/>
            <a:ext cx="1662986" cy="996779"/>
          </a:xfrm>
          <a:prstGeom prst="rect">
            <a:avLst/>
          </a:prstGeom>
          <a:solidFill>
            <a:schemeClr val="bg1">
              <a:lumMod val="75000"/>
            </a:schemeClr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orage of Extracts (4°C, Amber Glass Bottles)</a:t>
            </a:r>
          </a:p>
        </p:txBody>
      </p:sp>
      <p:sp>
        <p:nvSpPr>
          <p:cNvPr id="28" name="Arrow: Right 27">
            <a:extLst>
              <a:ext uri="{FF2B5EF4-FFF2-40B4-BE49-F238E27FC236}">
                <a16:creationId xmlns:a16="http://schemas.microsoft.com/office/drawing/2014/main" id="{5FB27F79-B477-486D-A2B9-4B070D6370E9}"/>
              </a:ext>
            </a:extLst>
          </p:cNvPr>
          <p:cNvSpPr/>
          <p:nvPr/>
        </p:nvSpPr>
        <p:spPr>
          <a:xfrm rot="10800000">
            <a:off x="6672629" y="2981135"/>
            <a:ext cx="722812" cy="209006"/>
          </a:xfrm>
          <a:prstGeom prst="rightArrow">
            <a:avLst/>
          </a:prstGeom>
          <a:solidFill>
            <a:schemeClr val="bg1">
              <a:lumMod val="75000"/>
            </a:schemeClr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00311EDC-6478-4BEA-ACCA-97655534D4A2}"/>
              </a:ext>
            </a:extLst>
          </p:cNvPr>
          <p:cNvSpPr/>
          <p:nvPr/>
        </p:nvSpPr>
        <p:spPr>
          <a:xfrm>
            <a:off x="2414023" y="2532434"/>
            <a:ext cx="1662986" cy="996779"/>
          </a:xfrm>
          <a:prstGeom prst="rect">
            <a:avLst/>
          </a:prstGeom>
          <a:solidFill>
            <a:schemeClr val="bg1">
              <a:lumMod val="75000"/>
            </a:schemeClr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llection &amp; Identification fresh fruits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DD4A0AD-5418-4A7F-9D00-88AFC2CAB260}"/>
              </a:ext>
            </a:extLst>
          </p:cNvPr>
          <p:cNvSpPr txBox="1"/>
          <p:nvPr/>
        </p:nvSpPr>
        <p:spPr>
          <a:xfrm>
            <a:off x="1793883" y="4347881"/>
            <a:ext cx="7912286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-1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ematic representation of the collection and extraction processes for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psicum frutescens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psicum annuum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uits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is figure shows the extraction workflow for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psicum frutescen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psicum annuu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uits. Fresh fruits are collected, washed, and air-dried for 15 days at 25°C, then ground into powder. The powder undergoes solvent extraction using methanol, n-butanol, n-hexane, and chloroform for 7 days with intermittent shaking. Extracts are filtered, concentrated by rotary evaporation at 40°C under vacuum, and stored in amber glass bottles at 4°C.</a:t>
            </a:r>
          </a:p>
        </p:txBody>
      </p:sp>
    </p:spTree>
    <p:extLst>
      <p:ext uri="{BB962C8B-B14F-4D97-AF65-F5344CB8AC3E}">
        <p14:creationId xmlns:p14="http://schemas.microsoft.com/office/powerpoint/2010/main" val="32675596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5611313A-0D27-4852-A27B-C5E6CB51476C}"/>
              </a:ext>
            </a:extLst>
          </p:cNvPr>
          <p:cNvSpPr/>
          <p:nvPr/>
        </p:nvSpPr>
        <p:spPr>
          <a:xfrm>
            <a:off x="4037388" y="182245"/>
            <a:ext cx="2910661" cy="618929"/>
          </a:xfrm>
          <a:prstGeom prst="rect">
            <a:avLst/>
          </a:prstGeom>
          <a:solidFill>
            <a:schemeClr val="bg1">
              <a:lumMod val="75000"/>
            </a:schemeClr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llection of for </a:t>
            </a:r>
            <a:r>
              <a:rPr lang="en-US" sz="12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psicum frutescens </a:t>
            </a: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2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psicum annuum</a:t>
            </a: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fruits 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882B5F14-B864-44E5-8201-1A27C29A9CF2}"/>
              </a:ext>
            </a:extLst>
          </p:cNvPr>
          <p:cNvSpPr/>
          <p:nvPr/>
        </p:nvSpPr>
        <p:spPr>
          <a:xfrm>
            <a:off x="4023500" y="1435980"/>
            <a:ext cx="2924552" cy="529287"/>
          </a:xfrm>
          <a:prstGeom prst="rect">
            <a:avLst/>
          </a:prstGeom>
          <a:solidFill>
            <a:schemeClr val="bg1">
              <a:lumMod val="75000"/>
            </a:schemeClr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paration: Clean, air-dry, and grind leaves 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7AE9E48B-85A5-44CF-8196-B124F852D8F6}"/>
              </a:ext>
            </a:extLst>
          </p:cNvPr>
          <p:cNvSpPr/>
          <p:nvPr/>
        </p:nvSpPr>
        <p:spPr>
          <a:xfrm>
            <a:off x="4436794" y="2624402"/>
            <a:ext cx="2097965" cy="554299"/>
          </a:xfrm>
          <a:prstGeom prst="rect">
            <a:avLst/>
          </a:prstGeom>
          <a:solidFill>
            <a:schemeClr val="bg1">
              <a:lumMod val="75000"/>
            </a:schemeClr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b-sampling 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FCCED40B-299E-4802-9D23-408DCD2EBABD}"/>
              </a:ext>
            </a:extLst>
          </p:cNvPr>
          <p:cNvSpPr/>
          <p:nvPr/>
        </p:nvSpPr>
        <p:spPr>
          <a:xfrm>
            <a:off x="346004" y="4623190"/>
            <a:ext cx="2418808" cy="1015527"/>
          </a:xfrm>
          <a:prstGeom prst="rect">
            <a:avLst/>
          </a:prstGeom>
          <a:solidFill>
            <a:schemeClr val="bg1">
              <a:lumMod val="75000"/>
            </a:schemeClr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isture Content (AOAC) </a:t>
            </a:r>
          </a:p>
          <a:p>
            <a:pPr algn="ctr"/>
            <a:r>
              <a:rPr lang="en-US" sz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rying at 105°C until a constant wt.</a:t>
            </a:r>
            <a:endParaRPr lang="en-US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8970B20B-5845-46E9-A698-257D95975C3E}"/>
              </a:ext>
            </a:extLst>
          </p:cNvPr>
          <p:cNvSpPr/>
          <p:nvPr/>
        </p:nvSpPr>
        <p:spPr>
          <a:xfrm>
            <a:off x="2893865" y="4627504"/>
            <a:ext cx="2287046" cy="1004369"/>
          </a:xfrm>
          <a:prstGeom prst="rect">
            <a:avLst/>
          </a:prstGeom>
          <a:solidFill>
            <a:schemeClr val="bg1">
              <a:lumMod val="75000"/>
            </a:schemeClr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sh Content (AOAC) </a:t>
            </a:r>
          </a:p>
          <a:p>
            <a:pPr algn="ctr"/>
            <a:r>
              <a:rPr lang="en-US" sz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uffle furnace at 600°C for 6 hours </a:t>
            </a: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→ total mineral content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EA051891-A5A2-4716-BE31-9140CC45EB61}"/>
              </a:ext>
            </a:extLst>
          </p:cNvPr>
          <p:cNvSpPr/>
          <p:nvPr/>
        </p:nvSpPr>
        <p:spPr>
          <a:xfrm>
            <a:off x="5309787" y="4620659"/>
            <a:ext cx="2694230" cy="1018058"/>
          </a:xfrm>
          <a:prstGeom prst="rect">
            <a:avLst/>
          </a:prstGeom>
          <a:solidFill>
            <a:schemeClr val="bg1">
              <a:lumMod val="75000"/>
            </a:schemeClr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rude Protein</a:t>
            </a:r>
          </a:p>
          <a:p>
            <a:pPr algn="ctr"/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icro-</a:t>
            </a:r>
            <a:r>
              <a:rPr lang="en-US" sz="12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jeldah</a:t>
            </a: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Method (AOAC) </a:t>
            </a:r>
          </a:p>
          <a:p>
            <a:pPr algn="ctr"/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₂SO₄ → Distill→ Titrate → % Protein 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CA75F1F1-FA4A-4D27-8041-CF693FE2EB4A}"/>
              </a:ext>
            </a:extLst>
          </p:cNvPr>
          <p:cNvSpPr/>
          <p:nvPr/>
        </p:nvSpPr>
        <p:spPr>
          <a:xfrm>
            <a:off x="8060771" y="4627504"/>
            <a:ext cx="2759630" cy="1004369"/>
          </a:xfrm>
          <a:prstGeom prst="rect">
            <a:avLst/>
          </a:prstGeom>
          <a:solidFill>
            <a:schemeClr val="bg1">
              <a:lumMod val="75000"/>
            </a:schemeClr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pids, Crude Fiber, and Mineral Analysis</a:t>
            </a:r>
          </a:p>
          <a:p>
            <a:pPr algn="ctr"/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Bligh &amp; Dyer, acid/ alkali digestion, &amp; AAS/Flame Photometry  (AOAC)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534CC059-B1DE-4623-BCD1-D028F852FABB}"/>
              </a:ext>
            </a:extLst>
          </p:cNvPr>
          <p:cNvCxnSpPr>
            <a:cxnSpLocks/>
          </p:cNvCxnSpPr>
          <p:nvPr/>
        </p:nvCxnSpPr>
        <p:spPr>
          <a:xfrm>
            <a:off x="5485777" y="853172"/>
            <a:ext cx="0" cy="530810"/>
          </a:xfrm>
          <a:prstGeom prst="straightConnector1">
            <a:avLst/>
          </a:prstGeom>
          <a:ln w="3492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EAC158A4-B6EE-4749-B3A2-17886D5258C9}"/>
              </a:ext>
            </a:extLst>
          </p:cNvPr>
          <p:cNvCxnSpPr>
            <a:cxnSpLocks/>
          </p:cNvCxnSpPr>
          <p:nvPr/>
        </p:nvCxnSpPr>
        <p:spPr>
          <a:xfrm>
            <a:off x="5472582" y="2048108"/>
            <a:ext cx="0" cy="530810"/>
          </a:xfrm>
          <a:prstGeom prst="straightConnector1">
            <a:avLst/>
          </a:prstGeom>
          <a:ln w="3492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54F2F06A-244F-433D-9BD4-4AE6A2ED98E7}"/>
              </a:ext>
            </a:extLst>
          </p:cNvPr>
          <p:cNvCxnSpPr>
            <a:cxnSpLocks/>
            <a:stCxn id="7" idx="2"/>
            <a:endCxn id="8" idx="0"/>
          </p:cNvCxnSpPr>
          <p:nvPr/>
        </p:nvCxnSpPr>
        <p:spPr>
          <a:xfrm flipH="1">
            <a:off x="1555408" y="3178701"/>
            <a:ext cx="3930369" cy="1444489"/>
          </a:xfrm>
          <a:prstGeom prst="straightConnector1">
            <a:avLst/>
          </a:prstGeom>
          <a:ln w="34925">
            <a:prstDash val="lgDashDot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49972821-7AF5-44CC-B06D-A64E8A08DCFF}"/>
              </a:ext>
            </a:extLst>
          </p:cNvPr>
          <p:cNvCxnSpPr>
            <a:cxnSpLocks/>
            <a:stCxn id="7" idx="2"/>
            <a:endCxn id="9" idx="0"/>
          </p:cNvCxnSpPr>
          <p:nvPr/>
        </p:nvCxnSpPr>
        <p:spPr>
          <a:xfrm flipH="1">
            <a:off x="4037388" y="3178701"/>
            <a:ext cx="1448389" cy="1448803"/>
          </a:xfrm>
          <a:prstGeom prst="straightConnector1">
            <a:avLst/>
          </a:prstGeom>
          <a:ln w="34925">
            <a:prstDash val="lgDashDot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06F538C6-8644-4C43-9F4C-9240A82691F5}"/>
              </a:ext>
            </a:extLst>
          </p:cNvPr>
          <p:cNvCxnSpPr>
            <a:cxnSpLocks/>
            <a:stCxn id="7" idx="2"/>
            <a:endCxn id="10" idx="0"/>
          </p:cNvCxnSpPr>
          <p:nvPr/>
        </p:nvCxnSpPr>
        <p:spPr>
          <a:xfrm>
            <a:off x="5485777" y="3178701"/>
            <a:ext cx="1171125" cy="1441958"/>
          </a:xfrm>
          <a:prstGeom prst="straightConnector1">
            <a:avLst/>
          </a:prstGeom>
          <a:ln w="34925">
            <a:prstDash val="lgDashDot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D602436F-0E65-42BB-A892-0AE9E474C9EB}"/>
              </a:ext>
            </a:extLst>
          </p:cNvPr>
          <p:cNvCxnSpPr>
            <a:cxnSpLocks/>
            <a:stCxn id="7" idx="2"/>
            <a:endCxn id="11" idx="0"/>
          </p:cNvCxnSpPr>
          <p:nvPr/>
        </p:nvCxnSpPr>
        <p:spPr>
          <a:xfrm>
            <a:off x="5485777" y="3178701"/>
            <a:ext cx="3954809" cy="1448803"/>
          </a:xfrm>
          <a:prstGeom prst="straightConnector1">
            <a:avLst/>
          </a:prstGeom>
          <a:ln w="34925">
            <a:prstDash val="lgDashDot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2AECC5F6-F662-404F-B82C-BD3775D9D8A6}"/>
              </a:ext>
            </a:extLst>
          </p:cNvPr>
          <p:cNvSpPr txBox="1"/>
          <p:nvPr/>
        </p:nvSpPr>
        <p:spPr>
          <a:xfrm>
            <a:off x="260475" y="5790433"/>
            <a:ext cx="11353260" cy="1015663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-2 : Schematic of the AOAC-based methods used for the proximate and mineral analysis of for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psicum frutescens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psicum annuum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uits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is figure outlines the AOAC-based analytical methods for proximate and mineral analysis of Capsicum frutescens and Capsicum annuum fruits. After collection, fruits are cleaned, air-dried, and ground into powder. The material is then sub-sampled for four parallel analyses: moisture content determination (drying at 105°C until constant weight), ash content analysis (muffle furnace at 600°C for 6 hours to determine total mineral content), crude protein quantification (Micro-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jeldah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ethod using H₂SO₄ distillation and titration), and lipids, crude fiber, and mineral analysis (using Bligh &amp; Dyer method, acid/alkali digestion, and AAS/Flame Photometry). All methods follow AOAC standard protocols.</a:t>
            </a:r>
          </a:p>
        </p:txBody>
      </p:sp>
    </p:spTree>
    <p:extLst>
      <p:ext uri="{BB962C8B-B14F-4D97-AF65-F5344CB8AC3E}">
        <p14:creationId xmlns:p14="http://schemas.microsoft.com/office/powerpoint/2010/main" val="1877721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Oval 20">
            <a:extLst>
              <a:ext uri="{FF2B5EF4-FFF2-40B4-BE49-F238E27FC236}">
                <a16:creationId xmlns:a16="http://schemas.microsoft.com/office/drawing/2014/main" id="{DCE8BA54-D707-4842-BE6A-F12F0DE66617}"/>
              </a:ext>
            </a:extLst>
          </p:cNvPr>
          <p:cNvSpPr/>
          <p:nvPr/>
        </p:nvSpPr>
        <p:spPr>
          <a:xfrm>
            <a:off x="5264987" y="1056408"/>
            <a:ext cx="2020440" cy="1530929"/>
          </a:xfrm>
          <a:prstGeom prst="ellipse">
            <a:avLst/>
          </a:prstGeom>
          <a:solidFill>
            <a:schemeClr val="bg1">
              <a:lumMod val="75000"/>
            </a:schemeClr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psicum frutescens and Capsicum annuum </a:t>
            </a:r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ruits </a:t>
            </a:r>
          </a:p>
        </p:txBody>
      </p:sp>
      <p:sp>
        <p:nvSpPr>
          <p:cNvPr id="23" name="Rectangle: Rounded Corners 22">
            <a:extLst>
              <a:ext uri="{FF2B5EF4-FFF2-40B4-BE49-F238E27FC236}">
                <a16:creationId xmlns:a16="http://schemas.microsoft.com/office/drawing/2014/main" id="{3BC85223-3924-4E0D-A4D1-E48EFFCDF182}"/>
              </a:ext>
            </a:extLst>
          </p:cNvPr>
          <p:cNvSpPr/>
          <p:nvPr/>
        </p:nvSpPr>
        <p:spPr>
          <a:xfrm>
            <a:off x="1746319" y="395476"/>
            <a:ext cx="3260361" cy="1237452"/>
          </a:xfrm>
          <a:prstGeom prst="roundRect">
            <a:avLst/>
          </a:prstGeom>
          <a:solidFill>
            <a:schemeClr val="bg1">
              <a:lumMod val="75000"/>
            </a:schemeClr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tioxidant Activity</a:t>
            </a:r>
          </a:p>
          <a:p>
            <a:pPr algn="ctr"/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DPPH Free Radical Scavenging Assay)</a:t>
            </a:r>
          </a:p>
          <a:p>
            <a:pPr marL="285750" indent="-285750" algn="ctr">
              <a:buFontTx/>
              <a:buChar char="-"/>
            </a:pP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centrations: 10 to 1000 µg/ml</a:t>
            </a:r>
          </a:p>
          <a:p>
            <a:pPr marL="285750" indent="-285750" algn="ctr">
              <a:buFontTx/>
              <a:buChar char="-"/>
            </a:pP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.004% DPPH, 30 min dark incubation</a:t>
            </a:r>
          </a:p>
          <a:p>
            <a:pPr marL="285750" indent="-285750" algn="ctr">
              <a:buFontTx/>
              <a:buChar char="-"/>
            </a:pP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asure absorbance at 517 nm </a:t>
            </a:r>
          </a:p>
          <a:p>
            <a:pPr marL="285750" indent="-285750" algn="ctr">
              <a:buFontTx/>
              <a:buChar char="-"/>
            </a:pPr>
            <a:r>
              <a:rPr lang="pt-BR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scorbic acid as control, calculate IC</a:t>
            </a:r>
            <a:r>
              <a:rPr lang="pt-BR" sz="1200" baseline="-25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r>
              <a:rPr lang="pt-BR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 algn="ctr">
              <a:buFontTx/>
              <a:buChar char="-"/>
            </a:pPr>
            <a:endParaRPr lang="en-US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Rectangle: Rounded Corners 33">
            <a:extLst>
              <a:ext uri="{FF2B5EF4-FFF2-40B4-BE49-F238E27FC236}">
                <a16:creationId xmlns:a16="http://schemas.microsoft.com/office/drawing/2014/main" id="{CFC48AFA-1E5B-42BF-95EF-B005BF6F5A90}"/>
              </a:ext>
            </a:extLst>
          </p:cNvPr>
          <p:cNvSpPr/>
          <p:nvPr/>
        </p:nvSpPr>
        <p:spPr>
          <a:xfrm>
            <a:off x="7507444" y="400392"/>
            <a:ext cx="3260361" cy="1237452"/>
          </a:xfrm>
          <a:prstGeom prst="roundRect">
            <a:avLst/>
          </a:prstGeom>
          <a:solidFill>
            <a:schemeClr val="bg1">
              <a:lumMod val="75000"/>
            </a:schemeClr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totoxicity Test</a:t>
            </a:r>
          </a:p>
          <a:p>
            <a:pPr algn="ctr"/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 Brine Shrimp Lethality Assay )               </a:t>
            </a:r>
          </a:p>
          <a:p>
            <a:pPr marL="171450" indent="-171450" algn="ctr">
              <a:buFontTx/>
              <a:buChar char="-"/>
            </a:pP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centrations: 10, 50, 100, 500, 1000 µg/ml</a:t>
            </a:r>
          </a:p>
          <a:p>
            <a:pPr algn="ctr"/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 24-hour exposure, count dead nauplii    </a:t>
            </a:r>
          </a:p>
          <a:p>
            <a:pPr algn="ctr"/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 Calculate LC50 using </a:t>
            </a:r>
            <a:r>
              <a:rPr lang="en-US" sz="12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obit</a:t>
            </a: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alysis </a:t>
            </a:r>
          </a:p>
        </p:txBody>
      </p:sp>
      <p:sp>
        <p:nvSpPr>
          <p:cNvPr id="35" name="Rectangle: Rounded Corners 34">
            <a:extLst>
              <a:ext uri="{FF2B5EF4-FFF2-40B4-BE49-F238E27FC236}">
                <a16:creationId xmlns:a16="http://schemas.microsoft.com/office/drawing/2014/main" id="{B624ACFE-B254-4D70-B34D-4B5BE4783D52}"/>
              </a:ext>
            </a:extLst>
          </p:cNvPr>
          <p:cNvSpPr/>
          <p:nvPr/>
        </p:nvSpPr>
        <p:spPr>
          <a:xfrm>
            <a:off x="1746319" y="2587337"/>
            <a:ext cx="3282263" cy="1231603"/>
          </a:xfrm>
          <a:prstGeom prst="roundRect">
            <a:avLst/>
          </a:prstGeom>
          <a:solidFill>
            <a:schemeClr val="bg1">
              <a:lumMod val="75000"/>
            </a:schemeClr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tibacterial Activity</a:t>
            </a:r>
          </a:p>
          <a:p>
            <a:pPr algn="ctr"/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Disc Diffusion Method)</a:t>
            </a:r>
          </a:p>
          <a:p>
            <a:pPr marL="171450" indent="-171450" algn="ctr">
              <a:buFontTx/>
              <a:buChar char="-"/>
            </a:pP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ram-positive and Gram-negative bacteria</a:t>
            </a:r>
          </a:p>
          <a:p>
            <a:pPr marL="171450" indent="-171450" algn="ctr">
              <a:buFontTx/>
              <a:buChar char="-"/>
            </a:pP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ueller-Hinton agar, 37°C, 24 hours</a:t>
            </a:r>
          </a:p>
          <a:p>
            <a:pPr marL="171450" indent="-171450" algn="ctr">
              <a:buFontTx/>
              <a:buChar char="-"/>
            </a:pP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asure zones of inhibition </a:t>
            </a:r>
          </a:p>
          <a:p>
            <a:pPr marL="171450" indent="-171450" algn="ctr">
              <a:buFontTx/>
              <a:buChar char="-"/>
            </a:pP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mpare with ciprofloxacin  </a:t>
            </a:r>
          </a:p>
        </p:txBody>
      </p:sp>
      <p:sp>
        <p:nvSpPr>
          <p:cNvPr id="36" name="Rectangle: Rounded Corners 35">
            <a:extLst>
              <a:ext uri="{FF2B5EF4-FFF2-40B4-BE49-F238E27FC236}">
                <a16:creationId xmlns:a16="http://schemas.microsoft.com/office/drawing/2014/main" id="{89979614-670E-46E9-BCEE-54A4EC8A60C1}"/>
              </a:ext>
            </a:extLst>
          </p:cNvPr>
          <p:cNvSpPr/>
          <p:nvPr/>
        </p:nvSpPr>
        <p:spPr>
          <a:xfrm>
            <a:off x="7485542" y="2587337"/>
            <a:ext cx="3282263" cy="1231603"/>
          </a:xfrm>
          <a:prstGeom prst="roundRect">
            <a:avLst/>
          </a:prstGeom>
          <a:solidFill>
            <a:schemeClr val="bg1">
              <a:lumMod val="75000"/>
            </a:schemeClr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ti-Arthritic Activity</a:t>
            </a:r>
          </a:p>
          <a:p>
            <a:pPr algn="ctr"/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Protein Denaturation Inhibition Test)</a:t>
            </a:r>
          </a:p>
          <a:p>
            <a:pPr marL="171450" indent="-171450" algn="ctr">
              <a:buFontTx/>
              <a:buChar char="-"/>
            </a:pP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cubate extracts with bovine serum albumin</a:t>
            </a:r>
          </a:p>
          <a:p>
            <a:pPr marL="171450" indent="-171450" algn="ctr">
              <a:buFontTx/>
              <a:buChar char="-"/>
            </a:pP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7°C for 30 min, heat at 70°C for 10 min</a:t>
            </a:r>
          </a:p>
          <a:p>
            <a:pPr marL="171450" indent="-171450" algn="ctr">
              <a:buFontTx/>
              <a:buChar char="-"/>
            </a:pP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asure absorbance at 660 nm</a:t>
            </a:r>
          </a:p>
          <a:p>
            <a:pPr marL="171450" indent="-171450" algn="ctr">
              <a:buFontTx/>
              <a:buChar char="-"/>
            </a:pP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lculate percentage inhibition   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5DF642F1-AC87-4E35-A0E6-D0EBB275F4B2}"/>
              </a:ext>
            </a:extLst>
          </p:cNvPr>
          <p:cNvSpPr txBox="1"/>
          <p:nvPr/>
        </p:nvSpPr>
        <p:spPr>
          <a:xfrm>
            <a:off x="1559218" y="4219420"/>
            <a:ext cx="9856495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-3 : Flowchart depicting the pharmacological evaluation of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psicum frutescens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psicum annuum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uits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tracts through various assays. 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is figure illustrates the pharmacological evaluation framework for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psicum frutescen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psicum annuu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uit extracts across four bioactivity assays. Antioxidant activity is assessed using the DPPH free radical scavenging assay (10-1000 µg/ml, 30-minute dark incubation, absorbance at 517 nm, with ascorbic acid as control). Cytotoxicity is evaluated via brine shrimp lethality assay (10-1000 µg/ml concentrations, 24-hour exposure, LC50 determined by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bi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sis). Antibacterial activity is tested using disc diffusion method against Gram-positive and Gram-negative bacteria on Mueller-Hinton agar (37°C, 24 hours), with ciprofloxacin as reference. Anti-arthritic activity is measured through protein denaturation inhibition test using bovine serum albumin (incubation at 37°C for 30 minutes, heating at 70°C for 10 minutes, absorbance at 660 nm).</a:t>
            </a:r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75BBB4B1-B5A1-4564-87A0-927837BA1749}"/>
              </a:ext>
            </a:extLst>
          </p:cNvPr>
          <p:cNvCxnSpPr>
            <a:cxnSpLocks/>
            <a:stCxn id="21" idx="2"/>
          </p:cNvCxnSpPr>
          <p:nvPr/>
        </p:nvCxnSpPr>
        <p:spPr>
          <a:xfrm flipH="1" flipV="1">
            <a:off x="4940225" y="1563177"/>
            <a:ext cx="324762" cy="258696"/>
          </a:xfrm>
          <a:prstGeom prst="straightConnector1">
            <a:avLst/>
          </a:prstGeom>
          <a:ln w="317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359A86E4-A789-4CA1-93B2-DD31AB20884F}"/>
              </a:ext>
            </a:extLst>
          </p:cNvPr>
          <p:cNvCxnSpPr>
            <a:cxnSpLocks/>
            <a:stCxn id="21" idx="3"/>
          </p:cNvCxnSpPr>
          <p:nvPr/>
        </p:nvCxnSpPr>
        <p:spPr>
          <a:xfrm flipH="1">
            <a:off x="5006682" y="2363138"/>
            <a:ext cx="554192" cy="353226"/>
          </a:xfrm>
          <a:prstGeom prst="straightConnector1">
            <a:avLst/>
          </a:prstGeom>
          <a:ln w="317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19A94509-D050-4669-87B3-9EFC6B10C597}"/>
              </a:ext>
            </a:extLst>
          </p:cNvPr>
          <p:cNvCxnSpPr>
            <a:cxnSpLocks/>
            <a:stCxn id="21" idx="5"/>
          </p:cNvCxnSpPr>
          <p:nvPr/>
        </p:nvCxnSpPr>
        <p:spPr>
          <a:xfrm>
            <a:off x="6989540" y="2363138"/>
            <a:ext cx="517903" cy="305322"/>
          </a:xfrm>
          <a:prstGeom prst="straightConnector1">
            <a:avLst/>
          </a:prstGeom>
          <a:ln w="317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A5C4BF48-AC76-4C3E-8C0D-9421E80CACC1}"/>
              </a:ext>
            </a:extLst>
          </p:cNvPr>
          <p:cNvCxnSpPr>
            <a:cxnSpLocks/>
            <a:stCxn id="21" idx="6"/>
          </p:cNvCxnSpPr>
          <p:nvPr/>
        </p:nvCxnSpPr>
        <p:spPr>
          <a:xfrm flipV="1">
            <a:off x="7285427" y="1632837"/>
            <a:ext cx="317590" cy="189036"/>
          </a:xfrm>
          <a:prstGeom prst="straightConnector1">
            <a:avLst/>
          </a:prstGeom>
          <a:ln w="317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878121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0</TotalTime>
  <Words>727</Words>
  <Application>Microsoft Office PowerPoint</Application>
  <PresentationFormat>Widescreen</PresentationFormat>
  <Paragraphs>50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マヒブ ムハマド</dc:creator>
  <cp:lastModifiedBy>Muhammad Mamunur Rashid Mahib</cp:lastModifiedBy>
  <cp:revision>18</cp:revision>
  <dcterms:created xsi:type="dcterms:W3CDTF">2025-11-13T16:22:00Z</dcterms:created>
  <dcterms:modified xsi:type="dcterms:W3CDTF">2025-11-20T12:12:36Z</dcterms:modified>
</cp:coreProperties>
</file>